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26" autoAdjust="0"/>
    <p:restoredTop sz="94660"/>
  </p:normalViewPr>
  <p:slideViewPr>
    <p:cSldViewPr snapToGrid="0">
      <p:cViewPr varScale="1">
        <p:scale>
          <a:sx n="112" d="100"/>
          <a:sy n="112" d="100"/>
        </p:scale>
        <p:origin x="54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Dikshya Sapkota" userId="76d3f829-1b89-41c2-8bc2-064e2010091f" providerId="ADAL" clId="{C836EDA2-A1C5-4B53-A36A-FA571FE2D93E}"/>
    <pc:docChg chg="modSld">
      <pc:chgData name="Dikshya Sapkota" userId="76d3f829-1b89-41c2-8bc2-064e2010091f" providerId="ADAL" clId="{C836EDA2-A1C5-4B53-A36A-FA571FE2D93E}" dt="2023-06-18T16:43:11.763" v="20" actId="20577"/>
      <pc:docMkLst>
        <pc:docMk/>
      </pc:docMkLst>
      <pc:sldChg chg="modSp mod">
        <pc:chgData name="Dikshya Sapkota" userId="76d3f829-1b89-41c2-8bc2-064e2010091f" providerId="ADAL" clId="{C836EDA2-A1C5-4B53-A36A-FA571FE2D93E}" dt="2023-06-18T16:43:11.763" v="20" actId="20577"/>
        <pc:sldMkLst>
          <pc:docMk/>
          <pc:sldMk cId="3577876875" sldId="256"/>
        </pc:sldMkLst>
        <pc:spChg chg="mod">
          <ac:chgData name="Dikshya Sapkota" userId="76d3f829-1b89-41c2-8bc2-064e2010091f" providerId="ADAL" clId="{C836EDA2-A1C5-4B53-A36A-FA571FE2D93E}" dt="2023-06-18T16:43:11.763" v="20" actId="20577"/>
          <ac:spMkLst>
            <pc:docMk/>
            <pc:sldMk cId="3577876875" sldId="256"/>
            <ac:spMk id="4" creationId="{AB450205-55A0-B3FF-E4EA-A7DBDC57E6A3}"/>
          </ac:spMkLst>
        </pc:spChg>
      </pc:sldChg>
    </pc:docChg>
  </pc:docChgLst>
  <pc:docChgLst>
    <pc:chgData name="Dikshya Sapkota" userId="76d3f829-1b89-41c2-8bc2-064e2010091f" providerId="ADAL" clId="{A25F576A-7EE3-4627-99EF-2430FEB5A2D5}"/>
    <pc:docChg chg="modSld">
      <pc:chgData name="Dikshya Sapkota" userId="76d3f829-1b89-41c2-8bc2-064e2010091f" providerId="ADAL" clId="{A25F576A-7EE3-4627-99EF-2430FEB5A2D5}" dt="2023-04-28T18:06:27.748" v="1" actId="20577"/>
      <pc:docMkLst>
        <pc:docMk/>
      </pc:docMkLst>
      <pc:sldChg chg="modSp mod">
        <pc:chgData name="Dikshya Sapkota" userId="76d3f829-1b89-41c2-8bc2-064e2010091f" providerId="ADAL" clId="{A25F576A-7EE3-4627-99EF-2430FEB5A2D5}" dt="2023-04-28T18:06:27.748" v="1" actId="20577"/>
        <pc:sldMkLst>
          <pc:docMk/>
          <pc:sldMk cId="3577876875" sldId="256"/>
        </pc:sldMkLst>
        <pc:spChg chg="mod">
          <ac:chgData name="Dikshya Sapkota" userId="76d3f829-1b89-41c2-8bc2-064e2010091f" providerId="ADAL" clId="{A25F576A-7EE3-4627-99EF-2430FEB5A2D5}" dt="2023-04-28T18:06:27.748" v="1" actId="20577"/>
          <ac:spMkLst>
            <pc:docMk/>
            <pc:sldMk cId="3577876875" sldId="256"/>
            <ac:spMk id="4" creationId="{AB450205-55A0-B3FF-E4EA-A7DBDC57E6A3}"/>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A5FF9F-E4FF-E580-8452-E2718BFFC29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3BB8D90-AD8E-3279-760F-38229DFDACB6}"/>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6DC546D-9FE8-6288-1700-C7BBBD6384CA}"/>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39C06FFC-CF2C-FD82-FA1E-C8A85C83EF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08C9529-C66E-BD77-3F7C-9441F3D9D30A}"/>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32916549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F5AAC9-02DD-60A7-6236-3F141283FE0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8C48D79-A5DC-5A06-BC89-1A45E4C97D2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9E80BC5-6645-B099-D813-82FDB98B6473}"/>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59D1B1A5-2ED6-CC21-AA50-56854F17C5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E45676-A05C-61B3-BD68-2D350E8AC3CE}"/>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37204652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C304121-7F4D-A0BD-D001-56590E20971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9F963DC-B35F-EA5E-86CE-2A7AB67F74D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1BE1FC6-2CDC-3A98-729C-C2A04D06FC6C}"/>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8433E65C-520C-2116-0AA7-C9C269A0A19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3FBFD5-C4AE-DB8C-7134-B00EE10E77B1}"/>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1283142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13BA66-263E-139E-38F9-CA3B0A4DA07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8CBAB87-9850-F3CF-E492-D312BB2CA15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7510DF5-119F-FAAF-E69A-D61A57D8A231}"/>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F1D6B2F6-1C23-2180-0CF8-E0104ED704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79EB449-5541-AF24-DA69-36F89076A689}"/>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30371515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224F7C-4362-AF8F-A8D5-923812ED7FF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C07D7AC-EC42-48D0-7F6F-9AAADB96D7A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D85D119-EECD-C11E-AF1A-E783950F86EA}"/>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23972B63-9ECF-DE6D-1645-1944ACE4C64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726372-127C-EA78-F5A6-2696599F1D4D}"/>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17322642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5C8D52-8006-C133-A089-EA9A841C8A8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57C5051-8AB4-5428-3E15-33D4A67739B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FB5AB591-C1C1-C9D2-E943-07E4E0855D2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1DAAE4D6-A83C-6D25-B4CC-8E8BD6EDE1BA}"/>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6" name="Footer Placeholder 5">
            <a:extLst>
              <a:ext uri="{FF2B5EF4-FFF2-40B4-BE49-F238E27FC236}">
                <a16:creationId xmlns:a16="http://schemas.microsoft.com/office/drawing/2014/main" id="{86CA3EAA-4836-F41C-27E2-68FA3235579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B50FEE-6A0B-0B77-573B-FE5A59B71B09}"/>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15504789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DAC909A-0247-D72C-10C7-C32AF7F0940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A7ACBAF-E30D-2E4F-528A-A4A72523B7C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52A2AFF-B17A-B562-6DFD-D799EBCD198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87E89B3-BE29-0595-9371-5969703D48F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3CE120E-A87C-4233-F73A-2808B775D676}"/>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83BDD13-D3ED-371F-C826-6E06DE61A724}"/>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8" name="Footer Placeholder 7">
            <a:extLst>
              <a:ext uri="{FF2B5EF4-FFF2-40B4-BE49-F238E27FC236}">
                <a16:creationId xmlns:a16="http://schemas.microsoft.com/office/drawing/2014/main" id="{EC2C5144-022F-BF5B-1BC8-FA394196F85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CD3D14E-DDF1-B16D-D025-3C1FD0209E98}"/>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23496852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FEFAF3C-BE85-0702-39EB-1E4793FB7AF2}"/>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9D0F0F0B-48B8-2536-C3D6-BEAAFFA8B28B}"/>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4" name="Footer Placeholder 3">
            <a:extLst>
              <a:ext uri="{FF2B5EF4-FFF2-40B4-BE49-F238E27FC236}">
                <a16:creationId xmlns:a16="http://schemas.microsoft.com/office/drawing/2014/main" id="{ACD76784-4A0E-9C64-949C-4390B7063A0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DCD1E915-A219-21EA-EDC0-E31C6CF511FF}"/>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45405561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480E00C-10C2-B0ED-99E7-B2CCE4E9E8A3}"/>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3" name="Footer Placeholder 2">
            <a:extLst>
              <a:ext uri="{FF2B5EF4-FFF2-40B4-BE49-F238E27FC236}">
                <a16:creationId xmlns:a16="http://schemas.microsoft.com/office/drawing/2014/main" id="{06E6D863-6134-1CBC-BCD7-77F596D5E5C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6EE8674-E140-3C67-A238-9A8B9EBE04C9}"/>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5136094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1FC89E-0B28-C90C-BB73-01DF722451F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2040EC6-BF8B-C28D-FD1B-AFA39A4BF56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F12C4FA-96B2-770A-0971-3EDE06ACD0F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10C7840-1653-620D-F261-69255ACA9F8E}"/>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6" name="Footer Placeholder 5">
            <a:extLst>
              <a:ext uri="{FF2B5EF4-FFF2-40B4-BE49-F238E27FC236}">
                <a16:creationId xmlns:a16="http://schemas.microsoft.com/office/drawing/2014/main" id="{948F41C0-444B-4254-F737-8BEF1FA1FF6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5B40F24-CF5B-25D2-2A01-BCEC1B462E0D}"/>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14483173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E465D5-9CFC-D71F-0958-9D2200039D8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6004DC7-CB66-B729-3103-A7F9A088CD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934D3576-25D5-2C4E-56EE-4552D9F12B9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AAF203D-79DC-BDCC-B4C8-286894840ACB}"/>
              </a:ext>
            </a:extLst>
          </p:cNvPr>
          <p:cNvSpPr>
            <a:spLocks noGrp="1"/>
          </p:cNvSpPr>
          <p:nvPr>
            <p:ph type="dt" sz="half" idx="10"/>
          </p:nvPr>
        </p:nvSpPr>
        <p:spPr/>
        <p:txBody>
          <a:bodyPr/>
          <a:lstStyle/>
          <a:p>
            <a:fld id="{7DA3143A-F48B-4D03-A565-A29C63AAE792}" type="datetimeFigureOut">
              <a:rPr lang="en-US" smtClean="0"/>
              <a:t>21-Jun-23</a:t>
            </a:fld>
            <a:endParaRPr lang="en-US"/>
          </a:p>
        </p:txBody>
      </p:sp>
      <p:sp>
        <p:nvSpPr>
          <p:cNvPr id="6" name="Footer Placeholder 5">
            <a:extLst>
              <a:ext uri="{FF2B5EF4-FFF2-40B4-BE49-F238E27FC236}">
                <a16:creationId xmlns:a16="http://schemas.microsoft.com/office/drawing/2014/main" id="{3C21F614-E0EF-4549-79A5-7AE220C2B5D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CE7210-55CB-D17F-1B03-F6FDA81D2253}"/>
              </a:ext>
            </a:extLst>
          </p:cNvPr>
          <p:cNvSpPr>
            <a:spLocks noGrp="1"/>
          </p:cNvSpPr>
          <p:nvPr>
            <p:ph type="sldNum" sz="quarter" idx="12"/>
          </p:nvPr>
        </p:nvSpPr>
        <p:spPr/>
        <p:txBody>
          <a:bodyPr/>
          <a:lstStyle/>
          <a:p>
            <a:fld id="{4CBDAC67-2EA3-4077-BEB0-CC3E796A16F8}" type="slidenum">
              <a:rPr lang="en-US" smtClean="0"/>
              <a:t>‹#›</a:t>
            </a:fld>
            <a:endParaRPr lang="en-US"/>
          </a:p>
        </p:txBody>
      </p:sp>
    </p:spTree>
    <p:extLst>
      <p:ext uri="{BB962C8B-B14F-4D97-AF65-F5344CB8AC3E}">
        <p14:creationId xmlns:p14="http://schemas.microsoft.com/office/powerpoint/2010/main" val="40729007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654CD9F-0FDD-D67C-8A6D-2E9340F0DCC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DACF40B-DAD7-2306-C94C-FB730F9773E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0BB95F-81CF-5744-1843-79A4A67DA39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DA3143A-F48B-4D03-A565-A29C63AAE792}" type="datetimeFigureOut">
              <a:rPr lang="en-US" smtClean="0"/>
              <a:t>21-Jun-23</a:t>
            </a:fld>
            <a:endParaRPr lang="en-US"/>
          </a:p>
        </p:txBody>
      </p:sp>
      <p:sp>
        <p:nvSpPr>
          <p:cNvPr id="5" name="Footer Placeholder 4">
            <a:extLst>
              <a:ext uri="{FF2B5EF4-FFF2-40B4-BE49-F238E27FC236}">
                <a16:creationId xmlns:a16="http://schemas.microsoft.com/office/drawing/2014/main" id="{1401515D-C1CF-1459-9997-73F926C4582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F02A960-DD47-9CBD-F56F-67512ADACFE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CBDAC67-2EA3-4077-BEB0-CC3E796A16F8}" type="slidenum">
              <a:rPr lang="en-US" smtClean="0"/>
              <a:t>‹#›</a:t>
            </a:fld>
            <a:endParaRPr lang="en-US"/>
          </a:p>
        </p:txBody>
      </p:sp>
    </p:spTree>
    <p:extLst>
      <p:ext uri="{BB962C8B-B14F-4D97-AF65-F5344CB8AC3E}">
        <p14:creationId xmlns:p14="http://schemas.microsoft.com/office/powerpoint/2010/main" val="252654598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B450205-55A0-B3FF-E4EA-A7DBDC57E6A3}"/>
              </a:ext>
            </a:extLst>
          </p:cNvPr>
          <p:cNvSpPr txBox="1"/>
          <p:nvPr/>
        </p:nvSpPr>
        <p:spPr>
          <a:xfrm>
            <a:off x="835742" y="619433"/>
            <a:ext cx="1986117" cy="400110"/>
          </a:xfrm>
          <a:prstGeom prst="rect">
            <a:avLst/>
          </a:prstGeom>
          <a:noFill/>
        </p:spPr>
        <p:txBody>
          <a:bodyPr wrap="square" rtlCol="0">
            <a:spAutoFit/>
          </a:bodyPr>
          <a:lstStyle/>
          <a:p>
            <a:endParaRPr lang="en-US" sz="2000" dirty="0"/>
          </a:p>
        </p:txBody>
      </p:sp>
      <p:pic>
        <p:nvPicPr>
          <p:cNvPr id="6" name="Picture 5" descr="A picture containing text, clipart&#10;&#10;Description automatically generated">
            <a:extLst>
              <a:ext uri="{FF2B5EF4-FFF2-40B4-BE49-F238E27FC236}">
                <a16:creationId xmlns:a16="http://schemas.microsoft.com/office/drawing/2014/main" id="{F44D5C02-13E7-B48E-4776-43864C0C77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83226" y="1101213"/>
            <a:ext cx="11051458" cy="3024649"/>
          </a:xfrm>
          <a:prstGeom prst="rect">
            <a:avLst/>
          </a:prstGeom>
        </p:spPr>
      </p:pic>
      <p:sp>
        <p:nvSpPr>
          <p:cNvPr id="8" name="TextBox 7">
            <a:extLst>
              <a:ext uri="{FF2B5EF4-FFF2-40B4-BE49-F238E27FC236}">
                <a16:creationId xmlns:a16="http://schemas.microsoft.com/office/drawing/2014/main" id="{6DA47689-CBEA-9333-514B-3E57B3A92415}"/>
              </a:ext>
            </a:extLst>
          </p:cNvPr>
          <p:cNvSpPr txBox="1"/>
          <p:nvPr/>
        </p:nvSpPr>
        <p:spPr>
          <a:xfrm>
            <a:off x="1596939" y="4125862"/>
            <a:ext cx="9488129" cy="1477328"/>
          </a:xfrm>
          <a:prstGeom prst="rect">
            <a:avLst/>
          </a:prstGeom>
          <a:noFill/>
        </p:spPr>
        <p:txBody>
          <a:bodyPr wrap="square" rtlCol="0">
            <a:spAutoFit/>
          </a:bodyPr>
          <a:lstStyle/>
          <a:p>
            <a:pPr algn="just"/>
            <a:r>
              <a:rPr lang="en-US" sz="1800" b="1" dirty="0"/>
              <a:t>Figure S2.</a:t>
            </a:r>
            <a:r>
              <a:rPr lang="en-US" sz="1800" dirty="0"/>
              <a:t> </a:t>
            </a:r>
            <a:r>
              <a:rPr lang="en-US" dirty="0">
                <a:latin typeface="Times New Roman" panose="02020603050405020304" pitchFamily="18" charset="0"/>
                <a:cs typeface="Times New Roman" panose="02020603050405020304" pitchFamily="18" charset="0"/>
              </a:rPr>
              <a:t>Inferred clusters in the 152 Chinese jujube accessions using STRUCTURE at K=4. </a:t>
            </a:r>
            <a:r>
              <a:rPr lang="en-US" sz="1800" dirty="0">
                <a:solidFill>
                  <a:srgbClr val="000000"/>
                </a:solidFill>
                <a:effectLst/>
                <a:latin typeface="Times New Roman" panose="02020603050405020304" pitchFamily="18" charset="0"/>
                <a:ea typeface="SimSun" panose="02010600030101010101" pitchFamily="2" charset="-122"/>
              </a:rPr>
              <a:t>An individual multilocus genotype is represented by each vertical line. Multiple genotypes from different clusters are admixed in individuals with multiple colors. Each color represents the cluster from which the genotype or partial genotype was produced and suggests its most likely ancestry. Clusters of individuals are represented by colors. </a:t>
            </a:r>
            <a:endParaRPr lang="en-US" dirty="0"/>
          </a:p>
        </p:txBody>
      </p:sp>
    </p:spTree>
    <p:extLst>
      <p:ext uri="{BB962C8B-B14F-4D97-AF65-F5344CB8AC3E}">
        <p14:creationId xmlns:p14="http://schemas.microsoft.com/office/powerpoint/2010/main" val="357787687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TotalTime>
  <Words>71</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ACE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onymous</dc:creator>
  <cp:lastModifiedBy>MDPI</cp:lastModifiedBy>
  <cp:revision>2</cp:revision>
  <dcterms:created xsi:type="dcterms:W3CDTF">2023-04-28T17:16:30Z</dcterms:created>
  <dcterms:modified xsi:type="dcterms:W3CDTF">2023-06-21T15:38:09Z</dcterms:modified>
</cp:coreProperties>
</file>